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20" d="100"/>
          <a:sy n="120" d="100"/>
        </p:scale>
        <p:origin x="-534" y="870"/>
      </p:cViewPr>
      <p:guideLst>
        <p:guide orient="horz" pos="1888"/>
        <p:guide orient="horz" pos="89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0752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717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9859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1827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3562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9969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9797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1666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2935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9096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9528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C397D1-3975-4B31-86FD-FA42E4BD1544}" type="datetimeFigureOut">
              <a:rPr lang="en-GB" smtClean="0"/>
              <a:t>29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25BFD9-878A-42CA-931A-CB2D5D88F3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9048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2094600" y="2175786"/>
            <a:ext cx="4896543" cy="2110298"/>
            <a:chOff x="2483768" y="1606734"/>
            <a:chExt cx="4896543" cy="211029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498" r="65084" b="25345"/>
            <a:stretch/>
          </p:blipFill>
          <p:spPr>
            <a:xfrm>
              <a:off x="4214356" y="2128470"/>
              <a:ext cx="1509772" cy="1561747"/>
            </a:xfrm>
            <a:prstGeom prst="ellipse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318" t="56851" r="-171" b="4773"/>
            <a:stretch/>
          </p:blipFill>
          <p:spPr>
            <a:xfrm>
              <a:off x="2483768" y="2128569"/>
              <a:ext cx="1599210" cy="1568091"/>
            </a:xfrm>
            <a:prstGeom prst="ellipse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74" t="14254" r="26378" b="5517"/>
            <a:stretch/>
          </p:blipFill>
          <p:spPr>
            <a:xfrm>
              <a:off x="5868144" y="2155384"/>
              <a:ext cx="1512167" cy="1561648"/>
            </a:xfrm>
            <a:prstGeom prst="ellipse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3779912" y="1606734"/>
              <a:ext cx="22322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Negative controls</a:t>
              </a:r>
              <a:endParaRPr lang="en-GB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007050" y="3212976"/>
              <a:ext cx="55264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ATM</a:t>
              </a:r>
              <a:endParaRPr lang="en-GB" sz="12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722892" y="3212976"/>
              <a:ext cx="57606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ATR</a:t>
              </a:r>
              <a:endParaRPr lang="en-GB" sz="12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192178" y="3212976"/>
              <a:ext cx="864097" cy="27699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DNA-</a:t>
              </a:r>
              <a:r>
                <a:rPr lang="en-GB" sz="1200" b="1" dirty="0" err="1" smtClean="0"/>
                <a:t>PKcs</a:t>
              </a:r>
              <a:endParaRPr lang="en-GB" sz="1200" b="1" dirty="0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540240" y="5085184"/>
            <a:ext cx="68407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Supplementary Figure S1:</a:t>
            </a:r>
            <a:r>
              <a:rPr lang="en-GB" sz="1400" dirty="0"/>
              <a:t>Negative controls with no primary antibody were included in each </a:t>
            </a:r>
            <a:r>
              <a:rPr lang="en-GB" sz="1400" dirty="0" smtClean="0"/>
              <a:t>run and shown here. </a:t>
            </a:r>
            <a:r>
              <a:rPr lang="en-GB" sz="1400" b="1" dirty="0" smtClean="0"/>
              <a:t> 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41242370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22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nivasan Madhusudan</dc:creator>
  <cp:lastModifiedBy> Srinivasan Madhusudan</cp:lastModifiedBy>
  <cp:revision>2</cp:revision>
  <dcterms:created xsi:type="dcterms:W3CDTF">2014-07-29T09:10:43Z</dcterms:created>
  <dcterms:modified xsi:type="dcterms:W3CDTF">2014-07-29T09:26:25Z</dcterms:modified>
</cp:coreProperties>
</file>